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429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364"/>
    <p:restoredTop sz="94643"/>
  </p:normalViewPr>
  <p:slideViewPr>
    <p:cSldViewPr snapToGrid="0">
      <p:cViewPr varScale="1">
        <p:scale>
          <a:sx n="59" d="100"/>
          <a:sy n="59" d="100"/>
        </p:scale>
        <p:origin x="192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06348B-107D-DF23-D79B-366A4C0B761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69EECAD-56DE-782F-DCDA-7D7B9E0F19F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DF5F51-446D-6AE1-C437-10276EA79F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CEB6C-8607-C84C-A8CB-16129048079E}" type="datetimeFigureOut">
              <a:rPr lang="en-US" smtClean="0"/>
              <a:t>7/13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01E874-631E-4BB7-7FC8-2D0A8BAE39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965B65-D3D1-5570-05CD-E329266C21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560F6-AEAE-0A49-881E-BC815C0AA9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32852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BDF3F4-D394-2F47-056A-CC5194CC52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84D2BE5-684B-F455-9814-29E17E553BD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692CAC-7897-3B71-276D-F85996E29E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CEB6C-8607-C84C-A8CB-16129048079E}" type="datetimeFigureOut">
              <a:rPr lang="en-US" smtClean="0"/>
              <a:t>7/13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49DF63-C771-7903-348F-88B8128008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BCA6AB-310F-0AB6-20A1-A56036C1D1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560F6-AEAE-0A49-881E-BC815C0AA9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54565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BEECD42-DA6C-2532-B7B6-DE46011802C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A6C3F1F-0AC1-D91C-B635-4A0A78F35F3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8DEE5E-BA71-F725-1252-9B5460D7BE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CEB6C-8607-C84C-A8CB-16129048079E}" type="datetimeFigureOut">
              <a:rPr lang="en-US" smtClean="0"/>
              <a:t>7/13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30BB58-8BC8-05AF-CD21-CC16E8E5AA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84DA4F-F1E4-59A9-EA9A-BED0EF30F8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560F6-AEAE-0A49-881E-BC815C0AA9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08537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F1DF6A-F0F2-0DB1-67BA-616179FAD0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BD91EDF-0C97-01CE-788B-BA8FC2B5C54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0D2A63-8D59-DB0D-3BBA-20CDF7F31C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CEB6C-8607-C84C-A8CB-16129048079E}" type="datetimeFigureOut">
              <a:rPr lang="en-US" smtClean="0"/>
              <a:t>7/13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AD8DF5-868D-5061-851F-DB85EBF9C7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36F21E-0479-92EE-C466-83C5B8EF02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560F6-AEAE-0A49-881E-BC815C0AA9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25834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5A5F9F-B19C-932F-1A18-E6CCEB1A8C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A8559B9-F3D5-7DEA-BBF9-8189A917FA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3CD53A3-208C-2C77-2865-6A4C6847A6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CEB6C-8607-C84C-A8CB-16129048079E}" type="datetimeFigureOut">
              <a:rPr lang="en-US" smtClean="0"/>
              <a:t>7/13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4A8F77-057C-B4E3-402A-3158A99AAA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90DDC5-F095-545C-B4ED-6DAB2700B5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560F6-AEAE-0A49-881E-BC815C0AA9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41030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1E4B73-307B-876B-101F-46651AEDC9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4CD5AD4-0CA0-CC26-54BA-5F7C8C8BD22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FDAC05F-96A0-F520-7AB4-3925180DA84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2610857-E687-C985-621B-E2874F5250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CEB6C-8607-C84C-A8CB-16129048079E}" type="datetimeFigureOut">
              <a:rPr lang="en-US" smtClean="0"/>
              <a:t>7/13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1FA38DB-442E-C43A-F08C-E8BB4213A5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8AD68A4-AD95-24CA-5105-EA7F6D476E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560F6-AEAE-0A49-881E-BC815C0AA9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6071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E51294-CCA7-1F2E-DDF0-C1C2D9F395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DF27307-4FE2-FFD6-B3E1-D30E6106C5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2096905-A721-66BF-54F5-4B826648C8D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87A65EC-1BA4-BA6B-3872-994F8E563AA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E40E6C9-9561-F5C0-9AD3-52D1AEBF3EF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C97A5E1-B062-86FE-F4D6-3CE7059887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CEB6C-8607-C84C-A8CB-16129048079E}" type="datetimeFigureOut">
              <a:rPr lang="en-US" smtClean="0"/>
              <a:t>7/13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CA901CC-CA09-7567-6DB7-330C475B56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1C6430D-0554-0216-C341-CB0C1FEC15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560F6-AEAE-0A49-881E-BC815C0AA9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32917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BF410C-CE5B-D7FA-62F6-64E1B2A531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CE4762F-69F2-863A-8C55-2E01D19C98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CEB6C-8607-C84C-A8CB-16129048079E}" type="datetimeFigureOut">
              <a:rPr lang="en-US" smtClean="0"/>
              <a:t>7/13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2F77402-3F59-69D5-F5FE-6E7E72809A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8AEE477-9F6B-6327-76EE-6C202822CA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560F6-AEAE-0A49-881E-BC815C0AA9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44327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03933AC-929F-A7DE-0061-FD279F489C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CEB6C-8607-C84C-A8CB-16129048079E}" type="datetimeFigureOut">
              <a:rPr lang="en-US" smtClean="0"/>
              <a:t>7/13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4D01904-5BC8-2ABC-0AAD-0302BD6039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C1CFB69-7C4C-191E-1956-45AC5EC45A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560F6-AEAE-0A49-881E-BC815C0AA9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18056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CAF704-3741-71E8-07E3-4E60EB131E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F936553-4224-6B3A-75A1-C0D54BE9E67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83E83CF-7866-FEB3-CB37-1148F79029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6D50F5D-7554-A059-49BD-CA689E0C31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CEB6C-8607-C84C-A8CB-16129048079E}" type="datetimeFigureOut">
              <a:rPr lang="en-US" smtClean="0"/>
              <a:t>7/13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7D0888C-BB0E-8DB3-1FA1-15B1C386F3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36D5A60-C7E3-D7CA-0AB1-E36AA7A6FF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560F6-AEAE-0A49-881E-BC815C0AA9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11069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4157F9-47ED-3180-5E18-27DF868E8E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4E979EB-0B76-8E94-8276-E243F3CD291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F41AE86-BDA8-D997-F50C-13BB6B64888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9B436DB-1DB9-A729-BEDF-ABC30673FF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CEB6C-8607-C84C-A8CB-16129048079E}" type="datetimeFigureOut">
              <a:rPr lang="en-US" smtClean="0"/>
              <a:t>7/13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0D68CFA-6054-CFB7-65A6-B91968C9AD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03C2458-1516-17F6-B702-FB992B0E84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B560F6-AEAE-0A49-881E-BC815C0AA9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95619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887866E-94B5-7A05-F919-80F8B37450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038F975-DFD7-B6EF-2492-BA88EE067C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0DA3EA-07C1-6DEE-3197-100BC5892BF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8FCEB6C-8607-C84C-A8CB-16129048079E}" type="datetimeFigureOut">
              <a:rPr lang="en-US" smtClean="0"/>
              <a:t>7/13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0D7ABB1-3D62-ED9D-A588-D3523CF5A64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C09971-3988-9B65-3F89-54540C20F9E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9B560F6-AEAE-0A49-881E-BC815C0AA9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4321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013996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59755A-79C1-E57C-F620-61D17503CA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23850" y="165100"/>
            <a:ext cx="11334750" cy="1325563"/>
          </a:xfrm>
        </p:spPr>
        <p:txBody>
          <a:bodyPr>
            <a:normAutofit/>
          </a:bodyPr>
          <a:lstStyle/>
          <a:p>
            <a:pPr algn="ctr"/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Rbin-2 Treatment Does Not Significantly Alter the Growth of Non-cancerous Breast Epithelial Cells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C8B69DC-2F72-B295-1C11-17F1BF16E50D}"/>
              </a:ext>
            </a:extLst>
          </p:cNvPr>
          <p:cNvSpPr txBox="1"/>
          <p:nvPr/>
        </p:nvSpPr>
        <p:spPr>
          <a:xfrm>
            <a:off x="89210" y="5950431"/>
            <a:ext cx="1219200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1. MCF-10A Noncancerous Breast Cells are Insensitive to the Growth Inhibitory Effects of Rbin-2. The MCF-10A cell lines were cultured in standard growth media and treated with DMSO vehicle, 0.1 µM, 1 µM, 3 µM, 6 µM, and 12 µM Rbin-2 or 33.3 µM 5 FU for 24, 48, and 72 hours. Absorbance was measured at 570 nm as an indicator of cell viability. Results are expressed as the cell viability ± SD (*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 &lt;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0.05), and data are representative from one of at least three independent experiments.</a:t>
            </a:r>
          </a:p>
          <a:p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5B41980E-1786-CBA3-0744-F28D907EAF4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86175" y="1910797"/>
            <a:ext cx="4610100" cy="3619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435532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17</Words>
  <Application>Microsoft Office PowerPoint</Application>
  <PresentationFormat>Widescreen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owerPoint Presentation</vt:lpstr>
      <vt:lpstr>Rbin-2 Treatment Does Not Significantly Alter the Growth of Non-cancerous Breast Epithelial Cell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ilghman, Syreeta</dc:creator>
  <cp:lastModifiedBy>Francesca Brentegani</cp:lastModifiedBy>
  <cp:revision>2</cp:revision>
  <dcterms:created xsi:type="dcterms:W3CDTF">2026-04-10T20:02:44Z</dcterms:created>
  <dcterms:modified xsi:type="dcterms:W3CDTF">2026-07-13T12:52:56Z</dcterms:modified>
</cp:coreProperties>
</file>